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2"/>
  </p:notesMasterIdLst>
  <p:sldIdLst>
    <p:sldId id="279" r:id="rId2"/>
    <p:sldId id="274" r:id="rId3"/>
    <p:sldId id="275" r:id="rId4"/>
    <p:sldId id="282" r:id="rId5"/>
    <p:sldId id="283" r:id="rId6"/>
    <p:sldId id="276" r:id="rId7"/>
    <p:sldId id="277" r:id="rId8"/>
    <p:sldId id="280" r:id="rId9"/>
    <p:sldId id="281" r:id="rId10"/>
    <p:sldId id="284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86">
          <p15:clr>
            <a:srgbClr val="A4A3A4"/>
          </p15:clr>
        </p15:guide>
        <p15:guide id="2" pos="3803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Vali Rauca" initials="VR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39" autoAdjust="0"/>
    <p:restoredTop sz="94660"/>
  </p:normalViewPr>
  <p:slideViewPr>
    <p:cSldViewPr snapToGrid="0">
      <p:cViewPr varScale="1">
        <p:scale>
          <a:sx n="69" d="100"/>
          <a:sy n="69" d="100"/>
        </p:scale>
        <p:origin x="-509" y="-67"/>
      </p:cViewPr>
      <p:guideLst>
        <p:guide orient="horz" pos="2186"/>
        <p:guide pos="380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commentAuthors" Target="commentAuthors.xml"/><Relationship Id="rId1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Vali Rauca" userId="7a5008d2cc9e051e" providerId="LiveId" clId="{6C94C80C-EA21-4BDB-8CDA-3BD1DA5A8509}"/>
    <pc:docChg chg="undo custSel modSld">
      <pc:chgData name="Vali Rauca" userId="7a5008d2cc9e051e" providerId="LiveId" clId="{6C94C80C-EA21-4BDB-8CDA-3BD1DA5A8509}" dt="2022-01-30T11:58:54.629" v="785" actId="13926"/>
      <pc:docMkLst>
        <pc:docMk/>
      </pc:docMkLst>
      <pc:sldChg chg="modSp mod">
        <pc:chgData name="Vali Rauca" userId="7a5008d2cc9e051e" providerId="LiveId" clId="{6C94C80C-EA21-4BDB-8CDA-3BD1DA5A8509}" dt="2022-01-30T11:51:42.772" v="217" actId="20577"/>
        <pc:sldMkLst>
          <pc:docMk/>
          <pc:sldMk cId="0" sldId="274"/>
        </pc:sldMkLst>
        <pc:spChg chg="mod">
          <ac:chgData name="Vali Rauca" userId="7a5008d2cc9e051e" providerId="LiveId" clId="{6C94C80C-EA21-4BDB-8CDA-3BD1DA5A8509}" dt="2022-01-30T11:51:42.772" v="217" actId="20577"/>
          <ac:spMkLst>
            <pc:docMk/>
            <pc:sldMk cId="0" sldId="274"/>
            <ac:spMk id="6" creationId="{00000000-0000-0000-0000-000000000000}"/>
          </ac:spMkLst>
        </pc:spChg>
      </pc:sldChg>
      <pc:sldChg chg="modSp mod">
        <pc:chgData name="Vali Rauca" userId="7a5008d2cc9e051e" providerId="LiveId" clId="{6C94C80C-EA21-4BDB-8CDA-3BD1DA5A8509}" dt="2022-01-30T11:53:11.965" v="743"/>
        <pc:sldMkLst>
          <pc:docMk/>
          <pc:sldMk cId="0" sldId="275"/>
        </pc:sldMkLst>
        <pc:spChg chg="mod">
          <ac:chgData name="Vali Rauca" userId="7a5008d2cc9e051e" providerId="LiveId" clId="{6C94C80C-EA21-4BDB-8CDA-3BD1DA5A8509}" dt="2022-01-30T11:53:11.965" v="743"/>
          <ac:spMkLst>
            <pc:docMk/>
            <pc:sldMk cId="0" sldId="275"/>
            <ac:spMk id="5" creationId="{00000000-0000-0000-0000-000000000000}"/>
          </ac:spMkLst>
        </pc:spChg>
      </pc:sldChg>
      <pc:sldChg chg="modSp mod">
        <pc:chgData name="Vali Rauca" userId="7a5008d2cc9e051e" providerId="LiveId" clId="{6C94C80C-EA21-4BDB-8CDA-3BD1DA5A8509}" dt="2022-01-30T11:58:54.629" v="785" actId="13926"/>
        <pc:sldMkLst>
          <pc:docMk/>
          <pc:sldMk cId="0" sldId="281"/>
        </pc:sldMkLst>
        <pc:spChg chg="mod">
          <ac:chgData name="Vali Rauca" userId="7a5008d2cc9e051e" providerId="LiveId" clId="{6C94C80C-EA21-4BDB-8CDA-3BD1DA5A8509}" dt="2022-01-30T11:58:54.629" v="785" actId="13926"/>
          <ac:spMkLst>
            <pc:docMk/>
            <pc:sldMk cId="0" sldId="281"/>
            <ac:spMk id="9" creationId="{00000000-0000-0000-0000-000000000000}"/>
          </ac:spMkLst>
        </pc:spChg>
      </pc:sldChg>
      <pc:sldChg chg="modSp mod">
        <pc:chgData name="Vali Rauca" userId="7a5008d2cc9e051e" providerId="LiveId" clId="{6C94C80C-EA21-4BDB-8CDA-3BD1DA5A8509}" dt="2022-01-30T11:55:55.689" v="757" actId="114"/>
        <pc:sldMkLst>
          <pc:docMk/>
          <pc:sldMk cId="0" sldId="282"/>
        </pc:sldMkLst>
        <pc:spChg chg="mod">
          <ac:chgData name="Vali Rauca" userId="7a5008d2cc9e051e" providerId="LiveId" clId="{6C94C80C-EA21-4BDB-8CDA-3BD1DA5A8509}" dt="2022-01-30T11:55:55.689" v="757" actId="114"/>
          <ac:spMkLst>
            <pc:docMk/>
            <pc:sldMk cId="0" sldId="282"/>
            <ac:spMk id="6" creationId="{00000000-0000-0000-0000-000000000000}"/>
          </ac:spMkLst>
        </pc:spChg>
      </pc:sldChg>
      <pc:sldChg chg="modSp mod">
        <pc:chgData name="Vali Rauca" userId="7a5008d2cc9e051e" providerId="LiveId" clId="{6C94C80C-EA21-4BDB-8CDA-3BD1DA5A8509}" dt="2022-01-30T11:57:55.405" v="783"/>
        <pc:sldMkLst>
          <pc:docMk/>
          <pc:sldMk cId="0" sldId="283"/>
        </pc:sldMkLst>
        <pc:spChg chg="mod">
          <ac:chgData name="Vali Rauca" userId="7a5008d2cc9e051e" providerId="LiveId" clId="{6C94C80C-EA21-4BDB-8CDA-3BD1DA5A8509}" dt="2022-01-30T11:57:55.405" v="783"/>
          <ac:spMkLst>
            <pc:docMk/>
            <pc:sldMk cId="0" sldId="283"/>
            <ac:spMk id="2" creationId="{00000000-0000-0000-0000-000000000000}"/>
          </ac:spMkLst>
        </pc:spChg>
        <pc:spChg chg="mod">
          <ac:chgData name="Vali Rauca" userId="7a5008d2cc9e051e" providerId="LiveId" clId="{6C94C80C-EA21-4BDB-8CDA-3BD1DA5A8509}" dt="2022-01-30T11:56:15.036" v="758" actId="6549"/>
          <ac:spMkLst>
            <pc:docMk/>
            <pc:sldMk cId="0" sldId="283"/>
            <ac:spMk id="22" creationId="{00000000-0000-0000-0000-000000000000}"/>
          </ac:spMkLst>
        </pc:spChg>
        <pc:spChg chg="mod">
          <ac:chgData name="Vali Rauca" userId="7a5008d2cc9e051e" providerId="LiveId" clId="{6C94C80C-EA21-4BDB-8CDA-3BD1DA5A8509}" dt="2022-01-30T11:56:29.046" v="761" actId="6549"/>
          <ac:spMkLst>
            <pc:docMk/>
            <pc:sldMk cId="0" sldId="283"/>
            <ac:spMk id="23" creationId="{00000000-0000-0000-0000-000000000000}"/>
          </ac:spMkLst>
        </pc:spChg>
      </pc:sldChg>
      <pc:sldChg chg="modSp mod">
        <pc:chgData name="Vali Rauca" userId="7a5008d2cc9e051e" providerId="LiveId" clId="{6C94C80C-EA21-4BDB-8CDA-3BD1DA5A8509}" dt="2022-01-30T11:58:34.249" v="784" actId="13926"/>
        <pc:sldMkLst>
          <pc:docMk/>
          <pc:sldMk cId="0" sldId="284"/>
        </pc:sldMkLst>
        <pc:spChg chg="mod">
          <ac:chgData name="Vali Rauca" userId="7a5008d2cc9e051e" providerId="LiveId" clId="{6C94C80C-EA21-4BDB-8CDA-3BD1DA5A8509}" dt="2022-01-30T11:58:34.249" v="784" actId="13926"/>
          <ac:spMkLst>
            <pc:docMk/>
            <pc:sldMk cId="0" sldId="284"/>
            <ac:spMk id="5" creationId="{00000000-0000-0000-0000-00000000000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02D5135-CA06-4A74-A27B-97228A390269}" type="datetimeFigureOut">
              <a:rPr lang="en-US" smtClean="0"/>
              <a:t>2/3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004B0D-98C0-413E-B2D6-D57E872ADE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36731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Text Placeholder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Text Placeholder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5A4A79-55A0-41D6-8E4B-1A41676D5605}" type="datetimeFigureOut">
              <a:rPr lang="en-US" smtClean="0"/>
              <a:t>2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BF54F-0B03-4A74-83D6-4F2444F6A2F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5A4A79-55A0-41D6-8E4B-1A41676D5605}" type="datetimeFigureOut">
              <a:rPr lang="en-US" smtClean="0"/>
              <a:t>2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BF54F-0B03-4A74-83D6-4F2444F6A2F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5A4A79-55A0-41D6-8E4B-1A41676D5605}" type="datetimeFigureOut">
              <a:rPr lang="en-US" smtClean="0"/>
              <a:t>2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BF54F-0B03-4A74-83D6-4F2444F6A2F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5A4A79-55A0-41D6-8E4B-1A41676D5605}" type="datetimeFigureOut">
              <a:rPr lang="en-US" smtClean="0"/>
              <a:t>2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BF54F-0B03-4A74-83D6-4F2444F6A2F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5A4A79-55A0-41D6-8E4B-1A41676D5605}" type="datetimeFigureOut">
              <a:rPr lang="en-US" smtClean="0"/>
              <a:t>2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BF54F-0B03-4A74-83D6-4F2444F6A2F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5A4A79-55A0-41D6-8E4B-1A41676D5605}" type="datetimeFigureOut">
              <a:rPr lang="en-US" smtClean="0"/>
              <a:t>2/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BF54F-0B03-4A74-83D6-4F2444F6A2F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5A4A79-55A0-41D6-8E4B-1A41676D5605}" type="datetimeFigureOut">
              <a:rPr lang="en-US" smtClean="0"/>
              <a:t>2/3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BF54F-0B03-4A74-83D6-4F2444F6A2F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5A4A79-55A0-41D6-8E4B-1A41676D5605}" type="datetimeFigureOut">
              <a:rPr lang="en-US" smtClean="0"/>
              <a:t>2/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BF54F-0B03-4A74-83D6-4F2444F6A2F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5A4A79-55A0-41D6-8E4B-1A41676D5605}" type="datetimeFigureOut">
              <a:rPr lang="en-US" smtClean="0"/>
              <a:t>2/3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BF54F-0B03-4A74-83D6-4F2444F6A2F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5A4A79-55A0-41D6-8E4B-1A41676D5605}" type="datetimeFigureOut">
              <a:rPr lang="en-US" smtClean="0"/>
              <a:t>2/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BF54F-0B03-4A74-83D6-4F2444F6A2F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5A4A79-55A0-41D6-8E4B-1A41676D5605}" type="datetimeFigureOut">
              <a:rPr lang="en-US" smtClean="0"/>
              <a:t>2/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BF54F-0B03-4A74-83D6-4F2444F6A2F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5A4A79-55A0-41D6-8E4B-1A41676D5605}" type="datetimeFigureOut">
              <a:rPr lang="en-US" smtClean="0"/>
              <a:t>2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1BF54F-0B03-4A74-83D6-4F2444F6A2FF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microsoft.com/office/2007/relationships/hdphoto" Target="../media/hdphoto2.wdp"/><Relationship Id="rId4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sz="3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 – </a:t>
            </a:r>
            <a:r>
              <a:rPr lang="en-US" sz="3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egrea</a:t>
            </a:r>
            <a:r>
              <a:rPr lang="en-US" sz="3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t al. 2022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473693" y="379978"/>
            <a:ext cx="98986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Full</a:t>
            </a:r>
            <a:r>
              <a:rPr lang="en-US" sz="2000" b="1" dirty="0">
                <a:latin typeface="Times New Roman" panose="02020603050405020304" pitchFamily="18" charset="0"/>
                <a:ea typeface="SimSun" panose="02010600030101010101" pitchFamily="2" charset="-122"/>
              </a:rPr>
              <a:t> length blots for representative cropped western blot pictures </a:t>
            </a:r>
            <a:endParaRPr lang="en-US" sz="2000" dirty="0"/>
          </a:p>
        </p:txBody>
      </p:sp>
      <p:sp>
        <p:nvSpPr>
          <p:cNvPr id="5" name="TextBox 4"/>
          <p:cNvSpPr txBox="1"/>
          <p:nvPr/>
        </p:nvSpPr>
        <p:spPr>
          <a:xfrm>
            <a:off x="2458279" y="1308576"/>
            <a:ext cx="7597074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 (corresponding to Supplementary </a:t>
            </a:r>
            <a:r>
              <a:rPr lang="ro-RO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ure 4) 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408" t="29903" r="15738" b="19223"/>
          <a:stretch>
            <a:fillRect/>
          </a:stretch>
        </p:blipFill>
        <p:spPr>
          <a:xfrm>
            <a:off x="3690890" y="1992668"/>
            <a:ext cx="5113538" cy="3488924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3976455" y="3825171"/>
            <a:ext cx="1433745" cy="46463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7632814" y="3917645"/>
            <a:ext cx="461639" cy="48827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2" name="TextBox 3"/>
          <p:cNvSpPr txBox="1"/>
          <p:nvPr/>
        </p:nvSpPr>
        <p:spPr>
          <a:xfrm>
            <a:off x="488271" y="3847545"/>
            <a:ext cx="5930284" cy="28873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1 -  Control</a:t>
            </a:r>
          </a:p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2 - SIM</a:t>
            </a:r>
          </a:p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3 - DOX</a:t>
            </a:r>
          </a:p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4 - SIM+DOX</a:t>
            </a:r>
          </a:p>
          <a:p>
            <a:pPr>
              <a:lnSpc>
                <a:spcPct val="13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5 - LCL-SIM</a:t>
            </a:r>
          </a:p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6 - LCL-DOX</a:t>
            </a:r>
          </a:p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7 - PEG-EV-DOX</a:t>
            </a:r>
          </a:p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8 - IL-13-LCL-SIM</a:t>
            </a:r>
          </a:p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9 - IL-13-LCL-SIM + PEG-EV-DOX</a:t>
            </a:r>
          </a:p>
        </p:txBody>
      </p:sp>
      <p:sp>
        <p:nvSpPr>
          <p:cNvPr id="19" name="TextBox 5"/>
          <p:cNvSpPr txBox="1"/>
          <p:nvPr/>
        </p:nvSpPr>
        <p:spPr>
          <a:xfrm>
            <a:off x="488271" y="3873069"/>
            <a:ext cx="1367162" cy="36830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20" name="TextBox 7"/>
          <p:cNvSpPr txBox="1"/>
          <p:nvPr/>
        </p:nvSpPr>
        <p:spPr>
          <a:xfrm>
            <a:off x="461645" y="6040755"/>
            <a:ext cx="2092960" cy="36830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21" name="TextBox 9"/>
          <p:cNvSpPr txBox="1"/>
          <p:nvPr/>
        </p:nvSpPr>
        <p:spPr>
          <a:xfrm>
            <a:off x="461645" y="5708650"/>
            <a:ext cx="2092325" cy="36830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22" name="TextBox 11"/>
          <p:cNvSpPr txBox="1"/>
          <p:nvPr/>
        </p:nvSpPr>
        <p:spPr>
          <a:xfrm>
            <a:off x="461645" y="6392545"/>
            <a:ext cx="3896360" cy="36830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37894" y="1513135"/>
            <a:ext cx="6516211" cy="3526815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290439" y="4929366"/>
            <a:ext cx="800765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ro-RO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ure 1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e depicting the generation of subcutaneous B16.F10 tumors in C57/BL6 mice and timeline of  sequential intravenous administration of IL-13-LCL-SIM and PEG-EV-DOX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IL-13-LCL-SIM—group treated with 5 mg/kg IL-13-LCL-SIM on days 7 and 10 after tumor cell inoculation; PEG-EV-DOX— group treated with 2 mg/kg PEG-EV-DOX on days 8 and 11 after tumor cell inoculation; IL-13-LCL-SIM+PEG-EV-DOX— the group received the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nanoformulations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sequentially - IL-13-LCL-SIM 5 mg/kg on days 7 and 10, respectively PEG-EV-DOX 2 mg/kg on days 8 and 11 after tumor cell inoculation. n=5/experimental group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744462" y="4993689"/>
            <a:ext cx="870307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ro-RO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ure 2.  Violin plot demonstrating the distribution of angiogenic proteins levels represented as percent of stimulation/inhibition in comparison to Control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ontrol—untreated group; IL-13-LCL-SIM—group treated with 5 mg/kg IL-13-LCL-SIM on days 7 and 10 after tumor cell inoculation; PEG-EV-DOX— group treated with 2 mg/kg PEG-EV-DOX on days 8 and 11 after tumor cell inoculation; IL-13-LCL-SIM+PEG-EV-DOX— the group received the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nanoformulations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sequentially - IL-13-LCL-SIM 5 mg/kg on days 7 and 10, respectively PEG-EV-DOX 2 mg/kg on days 8 and 11 after tumor cell inoculation</a:t>
            </a:r>
            <a:r>
              <a:rPr lang="ro-RO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77462" y="875841"/>
            <a:ext cx="4037076" cy="4117848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744462" y="4889447"/>
            <a:ext cx="8703076" cy="1383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ro-RO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ure 3. Evaluation of the effects of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noformulations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 enzymatic and nonenzymatic an</a:t>
            </a:r>
            <a:r>
              <a:rPr lang="ro-RO" alt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oxidant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ystems in B16.F10 melanoma. (A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talase activity was expressed as U/mg protein;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C was expressed as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ole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olox (nonenzymatic antioxidants)/mg protein. Measurements were performed in tumor lysates from mice treated with IL-13-LCL-SIM and PEG-EV-DOX as monotherapies as well as combined sequential therapy. Control—untreated group; IL-13-LCL-SIM—group treated with 5 mg/kg IL-13-LCL-SIM on days 7 and 10 after tumor cell inoculation; PEG-EV-DOX— group treated with 2 mg/kg PEG-EV-DOX on days 8 and 11 after tumor cell inoculation; IL-13-LCL-SIM+PEG-EV-DOX— the group received th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noformulation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quentially - IL-13-LCL-SIM 5 mg/kg on days 7 and 10, respectively PEG-EV-DOX 2 mg/kg on days 8 and 11 after tumor cell inoculation;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s </a:t>
            </a:r>
            <a:r>
              <a:rPr lang="ro-RO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ro-RO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 significan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 &gt; 0.05; 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2349" y="698184"/>
            <a:ext cx="6738285" cy="3927228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11655" y="5292090"/>
            <a:ext cx="8416925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ro-RO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ure 4. Evaluation of the effects of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noformulations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 HIF-1</a:t>
            </a:r>
            <a:r>
              <a:rPr lang="el-G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expression in B16.F10 melanoma. (A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stern blot analysis of HIF-1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tein expression; β-actin served as the loading control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ntification of the expression of HIF-1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umor lysates from each experimental group in comparison with their levels in control group. Data are expressed as the mean ± SD of 2 independent measurements. Control—untreated group; IL-13-LCL-SIM—group treated with 5 mg/kg IL-13-LCL-SIM on days 7 and 10 after tumor cell inoculation; PEG-EV-DOX— group treated with 2 mg/kg PEG-EV-DOX on days 8 and 11 after tumor cell inoculation; IL-13-LCL-SIM+PEG-EV-DOX— the group received th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noformulation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quentially - IL-13-LCL-SIM 5 mg/kg on days 7 and 10, respectively PEG-EV-DOX 2 mg/kg on days 8 and 11 after tumor cell inoculation; 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ns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,</a:t>
            </a:r>
            <a:r>
              <a:rPr kumimoji="0" lang="ro-RO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not significant;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gt;0.05;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4385569" y="398893"/>
            <a:ext cx="2998824" cy="1021624"/>
            <a:chOff x="1725964" y="901079"/>
            <a:chExt cx="1629797" cy="838942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094" t="56571" r="53458" b="36828"/>
            <a:stretch>
              <a:fillRect/>
            </a:stretch>
          </p:blipFill>
          <p:spPr>
            <a:xfrm flipH="1">
              <a:off x="2237173" y="1287260"/>
              <a:ext cx="1118588" cy="452761"/>
            </a:xfrm>
            <a:prstGeom prst="rect">
              <a:avLst/>
            </a:prstGeom>
          </p:spPr>
        </p:pic>
        <p:grpSp>
          <p:nvGrpSpPr>
            <p:cNvPr id="5" name="Group 4"/>
            <p:cNvGrpSpPr/>
            <p:nvPr/>
          </p:nvGrpSpPr>
          <p:grpSpPr>
            <a:xfrm>
              <a:off x="1725964" y="901079"/>
              <a:ext cx="1629797" cy="838942"/>
              <a:chOff x="1725964" y="901079"/>
              <a:chExt cx="1629797" cy="838942"/>
            </a:xfrm>
          </p:grpSpPr>
          <p:pic>
            <p:nvPicPr>
              <p:cNvPr id="6" name="Picture 5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aturation sat="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644" t="65649" r="45242" b="9694"/>
              <a:stretch>
                <a:fillRect/>
              </a:stretch>
            </p:blipFill>
            <p:spPr>
              <a:xfrm rot="5400000" flipV="1">
                <a:off x="2621129" y="517123"/>
                <a:ext cx="350675" cy="1118588"/>
              </a:xfrm>
              <a:prstGeom prst="rect">
                <a:avLst/>
              </a:prstGeom>
            </p:spPr>
          </p:pic>
          <p:pic>
            <p:nvPicPr>
              <p:cNvPr id="7" name="Picture 6"/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saturation sat="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8782" t="24945" r="46429" b="66597"/>
              <a:stretch>
                <a:fillRect/>
              </a:stretch>
            </p:blipFill>
            <p:spPr>
              <a:xfrm rot="5400000" flipV="1">
                <a:off x="1796986" y="830058"/>
                <a:ext cx="355108" cy="497151"/>
              </a:xfrm>
              <a:prstGeom prst="rect">
                <a:avLst/>
              </a:prstGeom>
            </p:spPr>
          </p:pic>
          <p:pic>
            <p:nvPicPr>
              <p:cNvPr id="8" name="Picture 7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saturation sat="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1351" t="58253" r="23107" b="35145"/>
              <a:stretch>
                <a:fillRect/>
              </a:stretch>
            </p:blipFill>
            <p:spPr>
              <a:xfrm flipH="1">
                <a:off x="1736320" y="1287260"/>
                <a:ext cx="486795" cy="452761"/>
              </a:xfrm>
              <a:prstGeom prst="rect">
                <a:avLst/>
              </a:prstGeom>
            </p:spPr>
          </p:pic>
        </p:grpSp>
      </p:grpSp>
      <p:sp>
        <p:nvSpPr>
          <p:cNvPr id="9" name="TextBox 8"/>
          <p:cNvSpPr txBox="1"/>
          <p:nvPr/>
        </p:nvSpPr>
        <p:spPr>
          <a:xfrm>
            <a:off x="3769342" y="499181"/>
            <a:ext cx="11807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F-1</a:t>
            </a:r>
            <a:r>
              <a:rPr lang="el-G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endParaRPr lang="en-US" sz="1200" dirty="0"/>
          </a:p>
        </p:txBody>
      </p:sp>
      <p:sp>
        <p:nvSpPr>
          <p:cNvPr id="17" name="TextBox 16"/>
          <p:cNvSpPr txBox="1"/>
          <p:nvPr/>
        </p:nvSpPr>
        <p:spPr>
          <a:xfrm>
            <a:off x="3773010" y="1011901"/>
            <a:ext cx="609452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en-US" sz="12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4438982" y="1434282"/>
            <a:ext cx="15269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 </a:t>
            </a:r>
            <a:r>
              <a:rPr lang="en-US" sz="900" b="1" dirty="0"/>
              <a:t>Control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5148208" y="1446798"/>
            <a:ext cx="15269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IL-13-LCL-SIM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5965941" y="1434282"/>
            <a:ext cx="1526959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PEG-EV-DOX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6669043" y="1421415"/>
            <a:ext cx="19785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IL-13_LCL-SIM+</a:t>
            </a:r>
          </a:p>
          <a:p>
            <a:r>
              <a:rPr lang="en-US" sz="900" b="1" dirty="0"/>
              <a:t>PEG-EV-DOX</a:t>
            </a: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13716" y="1781516"/>
            <a:ext cx="3858904" cy="3510585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88271" y="3847545"/>
            <a:ext cx="5930284" cy="28873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1 -  Control</a:t>
            </a:r>
          </a:p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2 - SIM</a:t>
            </a:r>
          </a:p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3 - DOX</a:t>
            </a:r>
          </a:p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4 - SIM+DOX</a:t>
            </a:r>
          </a:p>
          <a:p>
            <a:pPr>
              <a:lnSpc>
                <a:spcPct val="13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5 - LCL-SIM</a:t>
            </a:r>
          </a:p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6 - LCL-DOX</a:t>
            </a:r>
          </a:p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7 - PEG-EV-DOX</a:t>
            </a:r>
          </a:p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8 - IL-13-LCL-SIM</a:t>
            </a:r>
          </a:p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9 - IL-13-LCL-SIM + PEG-EV-DOX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913845" y="408373"/>
            <a:ext cx="98986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Full</a:t>
            </a:r>
            <a:r>
              <a:rPr lang="en-US" sz="2000" b="1" dirty="0">
                <a:latin typeface="Times New Roman" panose="02020603050405020304" pitchFamily="18" charset="0"/>
                <a:ea typeface="SimSun" panose="02010600030101010101" pitchFamily="2" charset="-122"/>
              </a:rPr>
              <a:t> length blots for representative cropped western blot pictures </a:t>
            </a:r>
            <a:endParaRPr lang="en-US" sz="2000" dirty="0"/>
          </a:p>
        </p:txBody>
      </p:sp>
      <p:sp>
        <p:nvSpPr>
          <p:cNvPr id="6" name="TextBox 5"/>
          <p:cNvSpPr txBox="1"/>
          <p:nvPr/>
        </p:nvSpPr>
        <p:spPr>
          <a:xfrm>
            <a:off x="488271" y="3873069"/>
            <a:ext cx="1367162" cy="36830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461645" y="6040755"/>
            <a:ext cx="2092960" cy="36830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488271" y="5714920"/>
            <a:ext cx="2092325" cy="36830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grpSp>
        <p:nvGrpSpPr>
          <p:cNvPr id="14" name="Group 13"/>
          <p:cNvGrpSpPr/>
          <p:nvPr/>
        </p:nvGrpSpPr>
        <p:grpSpPr>
          <a:xfrm>
            <a:off x="3012511" y="1722867"/>
            <a:ext cx="5672789" cy="4299153"/>
            <a:chOff x="2796551" y="1427518"/>
            <a:chExt cx="5672789" cy="4299153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796551" y="1427518"/>
              <a:ext cx="5672789" cy="4299153"/>
            </a:xfrm>
            <a:prstGeom prst="rect">
              <a:avLst/>
            </a:prstGeom>
          </p:spPr>
        </p:pic>
        <p:grpSp>
          <p:nvGrpSpPr>
            <p:cNvPr id="13" name="Group 12"/>
            <p:cNvGrpSpPr/>
            <p:nvPr/>
          </p:nvGrpSpPr>
          <p:grpSpPr>
            <a:xfrm>
              <a:off x="3601374" y="4492101"/>
              <a:ext cx="3453416" cy="551895"/>
              <a:chOff x="3601374" y="4492101"/>
              <a:chExt cx="3453416" cy="551895"/>
            </a:xfrm>
          </p:grpSpPr>
          <p:sp>
            <p:nvSpPr>
              <p:cNvPr id="5" name="TextBox 4"/>
              <p:cNvSpPr txBox="1"/>
              <p:nvPr/>
            </p:nvSpPr>
            <p:spPr>
              <a:xfrm>
                <a:off x="4598633" y="4492101"/>
                <a:ext cx="461639" cy="488272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en-US" dirty="0"/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6131512" y="4555724"/>
                <a:ext cx="461639" cy="488272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en-US" dirty="0"/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3601374" y="4492101"/>
                <a:ext cx="461639" cy="488272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en-US" dirty="0"/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6593151" y="4555724"/>
                <a:ext cx="461639" cy="488272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en-US" dirty="0"/>
              </a:p>
            </p:txBody>
          </p:sp>
        </p:grpSp>
      </p:grpSp>
      <p:sp>
        <p:nvSpPr>
          <p:cNvPr id="12" name="TextBox 11"/>
          <p:cNvSpPr txBox="1"/>
          <p:nvPr/>
        </p:nvSpPr>
        <p:spPr>
          <a:xfrm>
            <a:off x="461645" y="6392545"/>
            <a:ext cx="3896360" cy="36830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2583874" y="1209689"/>
            <a:ext cx="652221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x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orresponding to Figure 7 A in the manuscript) </a:t>
            </a: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TextBox 3"/>
          <p:cNvSpPr txBox="1"/>
          <p:nvPr/>
        </p:nvSpPr>
        <p:spPr>
          <a:xfrm>
            <a:off x="488271" y="3847545"/>
            <a:ext cx="5930284" cy="28873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1 -  Control</a:t>
            </a:r>
          </a:p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2 - SIM</a:t>
            </a:r>
          </a:p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3 - DOX</a:t>
            </a:r>
          </a:p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4 - SIM+DOX</a:t>
            </a:r>
          </a:p>
          <a:p>
            <a:pPr>
              <a:lnSpc>
                <a:spcPct val="13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5 - LCL-SIM</a:t>
            </a:r>
          </a:p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6 - LCL-DOX</a:t>
            </a:r>
          </a:p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7 - PEG-EV-DOX</a:t>
            </a:r>
          </a:p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8 - IL-13-LCL-SIM</a:t>
            </a:r>
          </a:p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9 - IL-13-LCL-SIM + PEG-EV-DOX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313895" y="408373"/>
            <a:ext cx="98986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Full</a:t>
            </a:r>
            <a:r>
              <a:rPr lang="en-US" sz="2000" b="1" dirty="0">
                <a:latin typeface="Times New Roman" panose="02020603050405020304" pitchFamily="18" charset="0"/>
                <a:ea typeface="SimSun" panose="02010600030101010101" pitchFamily="2" charset="-122"/>
              </a:rPr>
              <a:t> length blots for representative cropped western blot pictures </a:t>
            </a:r>
            <a:endParaRPr lang="en-US" sz="2000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32275" y="2033753"/>
            <a:ext cx="7745721" cy="3824122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7195397" y="4914914"/>
            <a:ext cx="687974" cy="59811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5091434" y="4914913"/>
            <a:ext cx="687974" cy="59811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8535971" y="4914912"/>
            <a:ext cx="687974" cy="59811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4409424" y="4914911"/>
            <a:ext cx="687974" cy="59811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3244029" y="1430889"/>
            <a:ext cx="652221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cl-xL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orresponding to Figure 7 C in the manuscript) </a:t>
            </a:r>
          </a:p>
        </p:txBody>
      </p:sp>
      <p:sp>
        <p:nvSpPr>
          <p:cNvPr id="19" name="TextBox 5"/>
          <p:cNvSpPr txBox="1"/>
          <p:nvPr/>
        </p:nvSpPr>
        <p:spPr>
          <a:xfrm>
            <a:off x="488271" y="3873069"/>
            <a:ext cx="1367162" cy="36830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20" name="TextBox 7"/>
          <p:cNvSpPr txBox="1"/>
          <p:nvPr/>
        </p:nvSpPr>
        <p:spPr>
          <a:xfrm>
            <a:off x="461645" y="6040755"/>
            <a:ext cx="2092960" cy="36830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21" name="TextBox 9"/>
          <p:cNvSpPr txBox="1"/>
          <p:nvPr/>
        </p:nvSpPr>
        <p:spPr>
          <a:xfrm>
            <a:off x="461645" y="5708650"/>
            <a:ext cx="2092325" cy="36830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22" name="TextBox 11"/>
          <p:cNvSpPr txBox="1"/>
          <p:nvPr/>
        </p:nvSpPr>
        <p:spPr>
          <a:xfrm>
            <a:off x="461645" y="6392545"/>
            <a:ext cx="3896360" cy="36830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428750" y="308957"/>
            <a:ext cx="98986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Full</a:t>
            </a:r>
            <a:r>
              <a:rPr lang="en-US" sz="2000" b="1" dirty="0">
                <a:latin typeface="Times New Roman" panose="02020603050405020304" pitchFamily="18" charset="0"/>
                <a:ea typeface="SimSun" panose="02010600030101010101" pitchFamily="2" charset="-122"/>
              </a:rPr>
              <a:t> length blots for representative cropped western blot pictures </a:t>
            </a:r>
            <a:endParaRPr lang="en-US" sz="2000" dirty="0"/>
          </a:p>
        </p:txBody>
      </p:sp>
      <p:sp>
        <p:nvSpPr>
          <p:cNvPr id="6" name="TextBox 5"/>
          <p:cNvSpPr txBox="1"/>
          <p:nvPr/>
        </p:nvSpPr>
        <p:spPr>
          <a:xfrm>
            <a:off x="3074168" y="1460338"/>
            <a:ext cx="759707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 (corresponding to Figure 7 A, C in the manuscript) 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6516" b="23400"/>
          <a:stretch>
            <a:fillRect/>
          </a:stretch>
        </p:blipFill>
        <p:spPr>
          <a:xfrm>
            <a:off x="3487074" y="2179228"/>
            <a:ext cx="5214026" cy="3527578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6468487" y="4546465"/>
            <a:ext cx="476657" cy="46463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5167766" y="4546465"/>
            <a:ext cx="476657" cy="46463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4685084" y="4546465"/>
            <a:ext cx="476657" cy="46463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7329917" y="4546465"/>
            <a:ext cx="476657" cy="46463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2" name="TextBox 3"/>
          <p:cNvSpPr txBox="1"/>
          <p:nvPr/>
        </p:nvSpPr>
        <p:spPr>
          <a:xfrm>
            <a:off x="488271" y="3847545"/>
            <a:ext cx="5930284" cy="28873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1 -  Control</a:t>
            </a:r>
          </a:p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2 - SIM</a:t>
            </a:r>
          </a:p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3 - DOX</a:t>
            </a:r>
          </a:p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4 - SIM+DOX</a:t>
            </a:r>
          </a:p>
          <a:p>
            <a:pPr>
              <a:lnSpc>
                <a:spcPct val="13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5 - LCL-SIM</a:t>
            </a:r>
          </a:p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6 - LCL-DOX</a:t>
            </a:r>
          </a:p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7 - PEG-EV-DOX</a:t>
            </a:r>
          </a:p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8 - IL-13-LCL-SIM</a:t>
            </a:r>
          </a:p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9 - IL-13-LCL-SIM + PEG-EV-DOX</a:t>
            </a:r>
          </a:p>
        </p:txBody>
      </p:sp>
      <p:sp>
        <p:nvSpPr>
          <p:cNvPr id="19" name="TextBox 5"/>
          <p:cNvSpPr txBox="1"/>
          <p:nvPr/>
        </p:nvSpPr>
        <p:spPr>
          <a:xfrm>
            <a:off x="488271" y="3873069"/>
            <a:ext cx="1367162" cy="36830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20" name="TextBox 7"/>
          <p:cNvSpPr txBox="1"/>
          <p:nvPr/>
        </p:nvSpPr>
        <p:spPr>
          <a:xfrm>
            <a:off x="461645" y="6040755"/>
            <a:ext cx="2092960" cy="36830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21" name="TextBox 9"/>
          <p:cNvSpPr txBox="1"/>
          <p:nvPr/>
        </p:nvSpPr>
        <p:spPr>
          <a:xfrm>
            <a:off x="461645" y="5708650"/>
            <a:ext cx="2092325" cy="36830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22" name="TextBox 11"/>
          <p:cNvSpPr txBox="1"/>
          <p:nvPr/>
        </p:nvSpPr>
        <p:spPr>
          <a:xfrm>
            <a:off x="461645" y="6392545"/>
            <a:ext cx="3896360" cy="36830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3"/>
          <p:cNvSpPr txBox="1"/>
          <p:nvPr/>
        </p:nvSpPr>
        <p:spPr>
          <a:xfrm>
            <a:off x="488271" y="3847545"/>
            <a:ext cx="5930284" cy="28873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1 -  Control</a:t>
            </a:r>
          </a:p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2 - SIM</a:t>
            </a:r>
          </a:p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3 - DOX</a:t>
            </a:r>
          </a:p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4 - SIM+DOX</a:t>
            </a:r>
          </a:p>
          <a:p>
            <a:pPr>
              <a:lnSpc>
                <a:spcPct val="13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5 - LCL-SIM</a:t>
            </a:r>
          </a:p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6 - LCL-DOX</a:t>
            </a:r>
          </a:p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7 - PEG-EV-DOX</a:t>
            </a:r>
          </a:p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8 - IL-13-LCL-SIM</a:t>
            </a:r>
          </a:p>
          <a:p>
            <a:pPr>
              <a:lnSpc>
                <a:spcPct val="11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9 - IL-13-LCL-SIM + PEG-EV-DOX</a:t>
            </a:r>
          </a:p>
        </p:txBody>
      </p:sp>
      <p:pic>
        <p:nvPicPr>
          <p:cNvPr id="1026" name="Picture 2" descr="C:\Users\Vali\Desktop\Articol in vivo 2022\IN VIVO 2019\in vivo-Giorgiana\in vivo\WB\Originale\20211001_134000 (HIF).jp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880" r="8732" b="34939"/>
          <a:stretch>
            <a:fillRect/>
          </a:stretch>
        </p:blipFill>
        <p:spPr bwMode="auto">
          <a:xfrm>
            <a:off x="3229623" y="2334110"/>
            <a:ext cx="5343882" cy="274653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226043" y="379978"/>
            <a:ext cx="98986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Full</a:t>
            </a:r>
            <a:r>
              <a:rPr lang="en-US" sz="2000" b="1" dirty="0">
                <a:latin typeface="Times New Roman" panose="02020603050405020304" pitchFamily="18" charset="0"/>
                <a:ea typeface="SimSun" panose="02010600030101010101" pitchFamily="2" charset="-122"/>
              </a:rPr>
              <a:t> length blots for representative cropped western blot pictures </a:t>
            </a:r>
            <a:endParaRPr lang="en-US" sz="2000" dirty="0"/>
          </a:p>
        </p:txBody>
      </p:sp>
      <p:sp>
        <p:nvSpPr>
          <p:cNvPr id="9" name="TextBox 8"/>
          <p:cNvSpPr txBox="1"/>
          <p:nvPr/>
        </p:nvSpPr>
        <p:spPr>
          <a:xfrm>
            <a:off x="3059558" y="1706515"/>
            <a:ext cx="6522211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F-1</a:t>
            </a:r>
            <a:r>
              <a:rPr lang="el-G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orresponding to Supplementary </a:t>
            </a:r>
            <a:r>
              <a:rPr lang="ro-RO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ure 4) 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812828" y="3865491"/>
            <a:ext cx="1433745" cy="46463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7127157" y="3780411"/>
            <a:ext cx="461639" cy="48827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19" name="TextBox 5"/>
          <p:cNvSpPr txBox="1"/>
          <p:nvPr/>
        </p:nvSpPr>
        <p:spPr>
          <a:xfrm>
            <a:off x="488271" y="3873069"/>
            <a:ext cx="1367162" cy="36830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20" name="TextBox 7"/>
          <p:cNvSpPr txBox="1"/>
          <p:nvPr/>
        </p:nvSpPr>
        <p:spPr>
          <a:xfrm>
            <a:off x="461645" y="6040755"/>
            <a:ext cx="2092960" cy="36830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21" name="TextBox 9"/>
          <p:cNvSpPr txBox="1"/>
          <p:nvPr/>
        </p:nvSpPr>
        <p:spPr>
          <a:xfrm>
            <a:off x="461645" y="5708650"/>
            <a:ext cx="2092325" cy="36830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22" name="TextBox 11"/>
          <p:cNvSpPr txBox="1"/>
          <p:nvPr/>
        </p:nvSpPr>
        <p:spPr>
          <a:xfrm>
            <a:off x="461645" y="6392545"/>
            <a:ext cx="3896360" cy="36830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752</Words>
  <Application>Microsoft Office PowerPoint</Application>
  <PresentationFormat>Custom</PresentationFormat>
  <Paragraphs>67</Paragraphs>
  <Slides>10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1" baseType="lpstr">
      <vt:lpstr>Office Theme</vt:lpstr>
      <vt:lpstr>Supplementary material – Negrea et al. 2022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in vivo 2019</dc:title>
  <dc:creator>Vali Rauca</dc:creator>
  <cp:lastModifiedBy>Vali</cp:lastModifiedBy>
  <cp:revision>220</cp:revision>
  <dcterms:created xsi:type="dcterms:W3CDTF">2021-11-17T14:21:00Z</dcterms:created>
  <dcterms:modified xsi:type="dcterms:W3CDTF">2022-02-03T17:22:5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91A73A4D65C042788E9910152A378191</vt:lpwstr>
  </property>
  <property fmtid="{D5CDD505-2E9C-101B-9397-08002B2CF9AE}" pid="3" name="KSOProductBuildVer">
    <vt:lpwstr>1033-11.2.0.10463</vt:lpwstr>
  </property>
</Properties>
</file>